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talie Marchevsky" initials="NM" lastIdx="3" clrIdx="0">
    <p:extLst>
      <p:ext uri="{19B8F6BF-5375-455C-9EA6-DF929625EA0E}">
        <p15:presenceInfo xmlns:p15="http://schemas.microsoft.com/office/powerpoint/2012/main" userId="S::paed1007@ox.ac.uk::c18673f5-e917-4940-ae8f-82786399aaf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99" autoAdjust="0"/>
    <p:restoredTop sz="95647" autoAdjust="0"/>
  </p:normalViewPr>
  <p:slideViewPr>
    <p:cSldViewPr snapToGrid="0">
      <p:cViewPr varScale="1">
        <p:scale>
          <a:sx n="77" d="100"/>
          <a:sy n="77" d="100"/>
        </p:scale>
        <p:origin x="1241" y="3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E96013-9F46-4625-B810-419E2F6D38D7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F109F9-028D-4062-8CD3-6D2F9AA1F6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19697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EF109F9-028D-4062-8CD3-6D2F9AA1F67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73038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3B104A-9972-4920-9300-6E744C1983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0753C3-0BFD-467A-A62B-D489C8236F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DB84F7-F67E-48F5-91FD-769F51371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25CACF-AA47-44EF-9C33-F86959BFD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8DDD68-2293-4775-9407-8DC771DC2B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4064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D8ED51-E4E8-416A-B209-8A78DAF315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CA8F3B-CA48-4AC9-9EFD-ECE9A2A61B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AEE545-4CA3-4417-8795-289AC7EBA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F0B76A-A3E1-4FB3-A6E0-82E111E32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EE9610-3A44-400F-90F8-F89E4F321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5018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935E7E-CF97-4404-B095-25BE4509D4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2B7F64-47D5-4E27-9865-9A36814DE6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C5A6BB-1DC4-4F10-9D7F-4335134027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C38A0C-F373-4992-B692-2FE6A5A47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D8D00D-F8C9-4BD1-8A33-4ED03FA39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8634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3E57C8-B2CA-48FB-9D3D-D3A64A80ED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B28169-7D0B-4761-BEEE-BDB21BA92D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DE44A7-BC06-4C1F-A481-6BC942338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FF0EFD-3B81-4E3D-8685-3E4984C82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5693F9-8D62-4F4F-A497-78C110060E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1439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EA85BF-155C-4C21-8542-5F0E070C6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0710BA-EDA6-4D24-8ED2-A4D8CB42C8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E20E59-C7CF-43BC-97CA-4293E3A9F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56088D-0148-4F96-86B0-0A0BCE0C30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B2B077-840A-4274-B5D6-D818AEC32D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5216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A1C1FA-A374-4C31-8C09-E01634AB41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D3B8C1-AFF9-4911-A044-9069A0A0E2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F470D8-61F1-43A7-9136-E4A6D25F71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307459-0088-4438-8A5A-EAE806034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833449-F81E-4F69-BE0F-DF1F2CCAE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6726B4-E84E-4AE3-B5B7-DC815184A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7464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7D0F02-8BA7-4981-9239-C4BBF471CF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AE8934-BF7D-4206-B68D-12C792E096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CAB4E0-71D2-4482-A8FD-FE0C07F807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0331EF-EBA5-4F73-B2FC-166A4CD47C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37BD6BC-DBD7-43C0-8AA8-1B4D284E7D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2D1C4A-1A0D-4F13-B6E9-0FDFA4211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A6A03FE-C605-4EAD-8C08-EAB6B7AB0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F26F0B3-EFA9-44B9-94B3-0AD312450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8161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9E6F1F-27C4-4FB7-9BB8-279F874D5B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56BEE61-3077-43A6-A8FE-FE3577478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5C0EE94-188F-49EB-9693-4B9931860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0D25A2-87DD-49CB-93B8-186B46F2C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7605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EABEA5-DB57-4E59-9CEF-5D4A06C31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C55C96-DE9C-430A-BD88-223764E02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80E956-A27F-48DA-9D08-0EC764906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6501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72A568-6BCF-49EF-8CA5-AF9C17CA0F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402861-7995-4779-AD5C-C08AECEAF8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0CE41C-86AE-461D-AD56-B7B8A5D73B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C45860-0C82-4CB4-B1BC-2A9C814589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F837A7-2C06-47F3-871A-90FABEFD3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4DA0C7-2936-490E-A6D5-E9347E3D8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0886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E6690-C5F1-4914-B0B6-A61F202A85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710447-9768-4532-BF8B-8B014E7424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FE1713-B811-412B-88C2-765C1F4312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910F9B-2DB7-420D-B6ED-B7A600829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4EA692-274F-4710-9AEC-E975EBE3D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0D3137-7723-424E-9164-9A001184C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03382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FC856FB-0942-4E75-8DF1-28E9E72105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0FE7EF-8DCB-4875-BF3A-D1DADDE8ED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63D6BA-20D5-45EC-8186-1D6BC13A98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C9022-FBEB-40EE-A07F-FEA57DFF2443}" type="datetimeFigureOut">
              <a:rPr lang="en-GB" smtClean="0"/>
              <a:t>21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423D4D-E9FA-4EBB-AD51-417D2EBE64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9A6F9C-404D-4DC2-8311-606794E371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71107A-5F98-45B6-B0D3-8F39DB5F2E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785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extBox 3">
            <a:extLst>
              <a:ext uri="{FF2B5EF4-FFF2-40B4-BE49-F238E27FC236}">
                <a16:creationId xmlns:a16="http://schemas.microsoft.com/office/drawing/2014/main" id="{E67C5730-69BE-47CF-9394-814970FE640B}"/>
              </a:ext>
            </a:extLst>
          </p:cNvPr>
          <p:cNvSpPr txBox="1"/>
          <p:nvPr/>
        </p:nvSpPr>
        <p:spPr>
          <a:xfrm>
            <a:off x="4852788" y="1395906"/>
            <a:ext cx="2021304" cy="328316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andomised into study </a:t>
            </a: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477</a:t>
            </a:r>
            <a:endParaRPr lang="en-GB" sz="12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9" name="TextBox 4">
            <a:extLst>
              <a:ext uri="{FF2B5EF4-FFF2-40B4-BE49-F238E27FC236}">
                <a16:creationId xmlns:a16="http://schemas.microsoft.com/office/drawing/2014/main" id="{84DC7308-BC71-42FF-B281-531DFE8BC325}"/>
              </a:ext>
            </a:extLst>
          </p:cNvPr>
          <p:cNvSpPr txBox="1"/>
          <p:nvPr/>
        </p:nvSpPr>
        <p:spPr>
          <a:xfrm>
            <a:off x="1884440" y="2376113"/>
            <a:ext cx="1739692" cy="45274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andomised into 6 &amp; 12 months schedule (Group A)</a:t>
            </a: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60</a:t>
            </a:r>
            <a:endParaRPr lang="en-GB" sz="9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1B30C994-5698-489B-B197-4AAE61780517}"/>
              </a:ext>
            </a:extLst>
          </p:cNvPr>
          <p:cNvCxnSpPr>
            <a:cxnSpLocks/>
            <a:endCxn id="79" idx="2"/>
          </p:cNvCxnSpPr>
          <p:nvPr/>
        </p:nvCxnSpPr>
        <p:spPr>
          <a:xfrm flipV="1">
            <a:off x="5863440" y="1724222"/>
            <a:ext cx="0" cy="43569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C67047D3-A607-4B49-A05F-1FCB53C0CF05}"/>
              </a:ext>
            </a:extLst>
          </p:cNvPr>
          <p:cNvCxnSpPr>
            <a:cxnSpLocks/>
          </p:cNvCxnSpPr>
          <p:nvPr/>
        </p:nvCxnSpPr>
        <p:spPr>
          <a:xfrm>
            <a:off x="2693110" y="2159920"/>
            <a:ext cx="616373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E7E0A30F-8101-4FAF-B34C-C0ABC6734BE2}"/>
              </a:ext>
            </a:extLst>
          </p:cNvPr>
          <p:cNvCxnSpPr>
            <a:cxnSpLocks/>
          </p:cNvCxnSpPr>
          <p:nvPr/>
        </p:nvCxnSpPr>
        <p:spPr>
          <a:xfrm>
            <a:off x="8856844" y="2159920"/>
            <a:ext cx="0" cy="21619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1C116E4B-CF67-41D2-A24F-8A3FFEB581A5}"/>
              </a:ext>
            </a:extLst>
          </p:cNvPr>
          <p:cNvCxnSpPr>
            <a:cxnSpLocks/>
          </p:cNvCxnSpPr>
          <p:nvPr/>
        </p:nvCxnSpPr>
        <p:spPr>
          <a:xfrm>
            <a:off x="2697061" y="2159920"/>
            <a:ext cx="0" cy="21619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78">
            <a:extLst>
              <a:ext uri="{FF2B5EF4-FFF2-40B4-BE49-F238E27FC236}">
                <a16:creationId xmlns:a16="http://schemas.microsoft.com/office/drawing/2014/main" id="{AD9C467E-54B6-446D-8C3B-06A3DD961249}"/>
              </a:ext>
            </a:extLst>
          </p:cNvPr>
          <p:cNvSpPr txBox="1"/>
          <p:nvPr/>
        </p:nvSpPr>
        <p:spPr>
          <a:xfrm>
            <a:off x="374904" y="828139"/>
            <a:ext cx="3785615" cy="106701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43 </a:t>
            </a: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ot randomised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:</a:t>
            </a:r>
            <a:b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</a:br>
            <a:endParaRPr lang="en-GB" sz="800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72 failed screening (n=29 due to being exposed to measles infection; n=24 child missed some vaccinations; n=19 other reasons)</a:t>
            </a: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=47 withdrew consent after screening before randomisation</a:t>
            </a:r>
          </a:p>
          <a:p>
            <a:pPr marL="87313" indent="-87313"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7 failed to make contact with parent after screening</a:t>
            </a:r>
            <a:endParaRPr lang="en-GB" sz="800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6 withdrawn due to investigator discretion after screening, before randomisation</a:t>
            </a: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 target enrolment number had already been achieved</a:t>
            </a:r>
            <a:endParaRPr lang="en-GB" sz="800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2" name="TextBox 3">
            <a:extLst>
              <a:ext uri="{FF2B5EF4-FFF2-40B4-BE49-F238E27FC236}">
                <a16:creationId xmlns:a16="http://schemas.microsoft.com/office/drawing/2014/main" id="{38CF30CE-40AE-40CE-AE2B-F4B1DBDF4E50}"/>
              </a:ext>
            </a:extLst>
          </p:cNvPr>
          <p:cNvSpPr txBox="1"/>
          <p:nvPr/>
        </p:nvSpPr>
        <p:spPr>
          <a:xfrm>
            <a:off x="4852788" y="101453"/>
            <a:ext cx="2021304" cy="328316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re-screening</a:t>
            </a:r>
            <a:endParaRPr lang="en-GB" sz="12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632</a:t>
            </a:r>
            <a:endParaRPr lang="en-GB" sz="12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5" name="TextBox 3">
            <a:extLst>
              <a:ext uri="{FF2B5EF4-FFF2-40B4-BE49-F238E27FC236}">
                <a16:creationId xmlns:a16="http://schemas.microsoft.com/office/drawing/2014/main" id="{09B5D6A8-E219-40A4-9E75-3245155FECB8}"/>
              </a:ext>
            </a:extLst>
          </p:cNvPr>
          <p:cNvSpPr txBox="1"/>
          <p:nvPr/>
        </p:nvSpPr>
        <p:spPr>
          <a:xfrm>
            <a:off x="4852788" y="685006"/>
            <a:ext cx="2021304" cy="328316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reening</a:t>
            </a:r>
            <a:endParaRPr lang="en-GB" sz="12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620</a:t>
            </a:r>
            <a:endParaRPr lang="en-GB" sz="12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7B074AAC-13BE-484D-A633-6E09E360766F}"/>
              </a:ext>
            </a:extLst>
          </p:cNvPr>
          <p:cNvCxnSpPr>
            <a:cxnSpLocks/>
          </p:cNvCxnSpPr>
          <p:nvPr/>
        </p:nvCxnSpPr>
        <p:spPr>
          <a:xfrm>
            <a:off x="5863440" y="2159920"/>
            <a:ext cx="0" cy="21619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4">
            <a:extLst>
              <a:ext uri="{FF2B5EF4-FFF2-40B4-BE49-F238E27FC236}">
                <a16:creationId xmlns:a16="http://schemas.microsoft.com/office/drawing/2014/main" id="{E4BCE0BD-8A87-4D6C-BF6F-76500D4A7E44}"/>
              </a:ext>
            </a:extLst>
          </p:cNvPr>
          <p:cNvSpPr txBox="1"/>
          <p:nvPr/>
        </p:nvSpPr>
        <p:spPr>
          <a:xfrm>
            <a:off x="4993594" y="2376114"/>
            <a:ext cx="1739692" cy="45274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andomised into 9 &amp; 18 months schedule (Group B)</a:t>
            </a: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</a:t>
            </a:r>
            <a:r>
              <a:rPr lang="en-GB" sz="9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59</a:t>
            </a:r>
            <a:endParaRPr lang="en-GB" sz="9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6" name="TextBox 4">
            <a:extLst>
              <a:ext uri="{FF2B5EF4-FFF2-40B4-BE49-F238E27FC236}">
                <a16:creationId xmlns:a16="http://schemas.microsoft.com/office/drawing/2014/main" id="{9203D6F2-80B6-4685-9FDA-0D1EDC3313E8}"/>
              </a:ext>
            </a:extLst>
          </p:cNvPr>
          <p:cNvSpPr txBox="1"/>
          <p:nvPr/>
        </p:nvSpPr>
        <p:spPr>
          <a:xfrm>
            <a:off x="7986998" y="2371397"/>
            <a:ext cx="1739692" cy="45080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andomised into 6 &amp; 18 months schedule (Group C)</a:t>
            </a: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58</a:t>
            </a:r>
            <a:endParaRPr lang="en-GB" sz="9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D4284733-D339-4A75-A73E-078E51DB2980}"/>
              </a:ext>
            </a:extLst>
          </p:cNvPr>
          <p:cNvCxnSpPr>
            <a:cxnSpLocks/>
            <a:endCxn id="55" idx="0"/>
          </p:cNvCxnSpPr>
          <p:nvPr/>
        </p:nvCxnSpPr>
        <p:spPr>
          <a:xfrm>
            <a:off x="5863440" y="429769"/>
            <a:ext cx="0" cy="2552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D4506045-5544-4617-8A6E-93E5988394D3}"/>
              </a:ext>
            </a:extLst>
          </p:cNvPr>
          <p:cNvCxnSpPr>
            <a:cxnSpLocks/>
          </p:cNvCxnSpPr>
          <p:nvPr/>
        </p:nvCxnSpPr>
        <p:spPr>
          <a:xfrm>
            <a:off x="5862528" y="1013322"/>
            <a:ext cx="0" cy="3825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A0590E9C-1337-4A9F-93DA-49AF38A47D05}"/>
              </a:ext>
            </a:extLst>
          </p:cNvPr>
          <p:cNvCxnSpPr>
            <a:cxnSpLocks/>
          </p:cNvCxnSpPr>
          <p:nvPr/>
        </p:nvCxnSpPr>
        <p:spPr>
          <a:xfrm flipH="1">
            <a:off x="5862528" y="530852"/>
            <a:ext cx="235335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81D8823F-C8DE-4AAE-A1BB-9EB861CC9FD7}"/>
              </a:ext>
            </a:extLst>
          </p:cNvPr>
          <p:cNvCxnSpPr>
            <a:cxnSpLocks/>
          </p:cNvCxnSpPr>
          <p:nvPr/>
        </p:nvCxnSpPr>
        <p:spPr>
          <a:xfrm flipH="1">
            <a:off x="4160520" y="1199786"/>
            <a:ext cx="17020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8">
            <a:extLst>
              <a:ext uri="{FF2B5EF4-FFF2-40B4-BE49-F238E27FC236}">
                <a16:creationId xmlns:a16="http://schemas.microsoft.com/office/drawing/2014/main" id="{0FBD6FBC-1E6D-474B-A4FF-1B4F56219618}"/>
              </a:ext>
            </a:extLst>
          </p:cNvPr>
          <p:cNvSpPr txBox="1"/>
          <p:nvPr/>
        </p:nvSpPr>
        <p:spPr>
          <a:xfrm>
            <a:off x="8215884" y="101454"/>
            <a:ext cx="2446020" cy="911868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012 failed</a:t>
            </a: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pre-screening:</a:t>
            </a:r>
          </a:p>
          <a:p>
            <a:pPr algn="ctr">
              <a:spcAft>
                <a:spcPts val="0"/>
              </a:spcAft>
            </a:pPr>
            <a:endParaRPr lang="en-GB" sz="800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394 stated need to consult the child’s father</a:t>
            </a: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389 not interested in the study</a:t>
            </a: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43 child did not meet the age criteria</a:t>
            </a: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6 child missed some vaccinations</a:t>
            </a: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80 other reasons</a:t>
            </a:r>
            <a:endParaRPr lang="en-GB" sz="800" dirty="0">
              <a:solidFill>
                <a:srgbClr val="000000"/>
              </a:solidFill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endParaRPr lang="en-GB" sz="800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B44CC35E-0513-4F1F-8E5E-FDFF604F51B4}"/>
              </a:ext>
            </a:extLst>
          </p:cNvPr>
          <p:cNvCxnSpPr>
            <a:cxnSpLocks/>
          </p:cNvCxnSpPr>
          <p:nvPr/>
        </p:nvCxnSpPr>
        <p:spPr>
          <a:xfrm>
            <a:off x="8877992" y="2822204"/>
            <a:ext cx="688" cy="39363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54D8907C-AE62-4180-B612-B83A63BA68CB}"/>
              </a:ext>
            </a:extLst>
          </p:cNvPr>
          <p:cNvCxnSpPr>
            <a:cxnSpLocks/>
            <a:stCxn id="65" idx="2"/>
          </p:cNvCxnSpPr>
          <p:nvPr/>
        </p:nvCxnSpPr>
        <p:spPr>
          <a:xfrm flipH="1">
            <a:off x="5862528" y="2828854"/>
            <a:ext cx="912" cy="39897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4">
            <a:extLst>
              <a:ext uri="{FF2B5EF4-FFF2-40B4-BE49-F238E27FC236}">
                <a16:creationId xmlns:a16="http://schemas.microsoft.com/office/drawing/2014/main" id="{3512EBA2-DA79-4F0D-BAE9-162535F0D7D2}"/>
              </a:ext>
            </a:extLst>
          </p:cNvPr>
          <p:cNvSpPr txBox="1"/>
          <p:nvPr/>
        </p:nvSpPr>
        <p:spPr>
          <a:xfrm>
            <a:off x="1884440" y="3223116"/>
            <a:ext cx="1739692" cy="32173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eceived MR1 within trial</a:t>
            </a: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</a:t>
            </a:r>
            <a:r>
              <a:rPr lang="en-GB" sz="9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58</a:t>
            </a:r>
            <a:endParaRPr lang="en-GB" sz="9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4" name="TextBox 4">
            <a:extLst>
              <a:ext uri="{FF2B5EF4-FFF2-40B4-BE49-F238E27FC236}">
                <a16:creationId xmlns:a16="http://schemas.microsoft.com/office/drawing/2014/main" id="{98958ACE-7E95-4857-95B5-0D21EA1AE5B8}"/>
              </a:ext>
            </a:extLst>
          </p:cNvPr>
          <p:cNvSpPr txBox="1"/>
          <p:nvPr/>
        </p:nvSpPr>
        <p:spPr>
          <a:xfrm>
            <a:off x="4993594" y="3223116"/>
            <a:ext cx="1739692" cy="32173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eceived MR1 within trial</a:t>
            </a: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37</a:t>
            </a:r>
            <a:endParaRPr lang="en-GB" sz="9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0" name="TextBox 4">
            <a:extLst>
              <a:ext uri="{FF2B5EF4-FFF2-40B4-BE49-F238E27FC236}">
                <a16:creationId xmlns:a16="http://schemas.microsoft.com/office/drawing/2014/main" id="{7090549E-78F3-4EAC-9294-FD05DC704784}"/>
              </a:ext>
            </a:extLst>
          </p:cNvPr>
          <p:cNvSpPr txBox="1"/>
          <p:nvPr/>
        </p:nvSpPr>
        <p:spPr>
          <a:xfrm>
            <a:off x="7992507" y="3223116"/>
            <a:ext cx="1739692" cy="32173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eceived MR1 within trial</a:t>
            </a: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55</a:t>
            </a:r>
            <a:endParaRPr lang="en-GB" sz="9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1" name="TextBox 4">
            <a:extLst>
              <a:ext uri="{FF2B5EF4-FFF2-40B4-BE49-F238E27FC236}">
                <a16:creationId xmlns:a16="http://schemas.microsoft.com/office/drawing/2014/main" id="{D1A08072-1C21-432F-B639-F833953098D9}"/>
              </a:ext>
            </a:extLst>
          </p:cNvPr>
          <p:cNvSpPr txBox="1"/>
          <p:nvPr/>
        </p:nvSpPr>
        <p:spPr>
          <a:xfrm>
            <a:off x="1884440" y="4074834"/>
            <a:ext cx="1739692" cy="32173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eceived MR2 within trial</a:t>
            </a: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</a:t>
            </a:r>
            <a:r>
              <a:rPr lang="en-GB" sz="9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47</a:t>
            </a:r>
            <a:endParaRPr lang="en-GB" sz="9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E5BC1DA3-45C5-40FE-8905-89A77468D367}"/>
              </a:ext>
            </a:extLst>
          </p:cNvPr>
          <p:cNvCxnSpPr>
            <a:cxnSpLocks/>
          </p:cNvCxnSpPr>
          <p:nvPr/>
        </p:nvCxnSpPr>
        <p:spPr>
          <a:xfrm>
            <a:off x="2727687" y="3544846"/>
            <a:ext cx="0" cy="5347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Box 4">
            <a:extLst>
              <a:ext uri="{FF2B5EF4-FFF2-40B4-BE49-F238E27FC236}">
                <a16:creationId xmlns:a16="http://schemas.microsoft.com/office/drawing/2014/main" id="{A27AD70E-DB9A-4F43-834E-41C754FFEBF9}"/>
              </a:ext>
            </a:extLst>
          </p:cNvPr>
          <p:cNvSpPr txBox="1"/>
          <p:nvPr/>
        </p:nvSpPr>
        <p:spPr>
          <a:xfrm>
            <a:off x="4993594" y="4074834"/>
            <a:ext cx="1739692" cy="32173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eceived MR2 within trial</a:t>
            </a: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</a:t>
            </a:r>
            <a:r>
              <a:rPr lang="en-GB" sz="9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31</a:t>
            </a:r>
            <a:endParaRPr lang="en-GB" sz="9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AA1416A7-6F3C-45BB-8DB0-8912771B8604}"/>
              </a:ext>
            </a:extLst>
          </p:cNvPr>
          <p:cNvCxnSpPr>
            <a:cxnSpLocks/>
          </p:cNvCxnSpPr>
          <p:nvPr/>
        </p:nvCxnSpPr>
        <p:spPr>
          <a:xfrm>
            <a:off x="5862528" y="3544846"/>
            <a:ext cx="0" cy="5347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TextBox 4">
            <a:extLst>
              <a:ext uri="{FF2B5EF4-FFF2-40B4-BE49-F238E27FC236}">
                <a16:creationId xmlns:a16="http://schemas.microsoft.com/office/drawing/2014/main" id="{659762A0-17EB-4D61-A456-F0DBCA89FE5F}"/>
              </a:ext>
            </a:extLst>
          </p:cNvPr>
          <p:cNvSpPr txBox="1"/>
          <p:nvPr/>
        </p:nvSpPr>
        <p:spPr>
          <a:xfrm>
            <a:off x="7986998" y="4074834"/>
            <a:ext cx="1739692" cy="32173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eceived MR2 within trial</a:t>
            </a:r>
          </a:p>
          <a:p>
            <a:pPr algn="ctr">
              <a:spcAft>
                <a:spcPts val="0"/>
              </a:spcAft>
            </a:pPr>
            <a:r>
              <a:rPr lang="en-GB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42</a:t>
            </a:r>
            <a:endParaRPr lang="en-GB" sz="9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87604FAD-3633-49C6-85A5-4188750375FD}"/>
              </a:ext>
            </a:extLst>
          </p:cNvPr>
          <p:cNvCxnSpPr>
            <a:cxnSpLocks/>
          </p:cNvCxnSpPr>
          <p:nvPr/>
        </p:nvCxnSpPr>
        <p:spPr>
          <a:xfrm>
            <a:off x="8881332" y="3544846"/>
            <a:ext cx="0" cy="5347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11A10851-F5DC-43E1-9AFE-5ED562CC86B7}"/>
              </a:ext>
            </a:extLst>
          </p:cNvPr>
          <p:cNvCxnSpPr>
            <a:cxnSpLocks/>
          </p:cNvCxnSpPr>
          <p:nvPr/>
        </p:nvCxnSpPr>
        <p:spPr>
          <a:xfrm flipH="1">
            <a:off x="1795832" y="3015385"/>
            <a:ext cx="9306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TextBox 78">
            <a:extLst>
              <a:ext uri="{FF2B5EF4-FFF2-40B4-BE49-F238E27FC236}">
                <a16:creationId xmlns:a16="http://schemas.microsoft.com/office/drawing/2014/main" id="{3DBE1356-39D6-4875-B1F8-7B0BECC70225}"/>
              </a:ext>
            </a:extLst>
          </p:cNvPr>
          <p:cNvSpPr txBox="1"/>
          <p:nvPr/>
        </p:nvSpPr>
        <p:spPr>
          <a:xfrm>
            <a:off x="162179" y="2899275"/>
            <a:ext cx="1626946" cy="232219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2 withdrew consent before MR1</a:t>
            </a:r>
          </a:p>
        </p:txBody>
      </p: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D665722E-26F1-4953-8CC7-DE81A6EE9DB5}"/>
              </a:ext>
            </a:extLst>
          </p:cNvPr>
          <p:cNvCxnSpPr>
            <a:cxnSpLocks/>
          </p:cNvCxnSpPr>
          <p:nvPr/>
        </p:nvCxnSpPr>
        <p:spPr>
          <a:xfrm flipH="1">
            <a:off x="8877992" y="3006112"/>
            <a:ext cx="84869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78">
            <a:extLst>
              <a:ext uri="{FF2B5EF4-FFF2-40B4-BE49-F238E27FC236}">
                <a16:creationId xmlns:a16="http://schemas.microsoft.com/office/drawing/2014/main" id="{0FE9AE62-B0C1-4E88-822E-A73BA281CF64}"/>
              </a:ext>
            </a:extLst>
          </p:cNvPr>
          <p:cNvSpPr txBox="1"/>
          <p:nvPr/>
        </p:nvSpPr>
        <p:spPr>
          <a:xfrm>
            <a:off x="9726690" y="2870482"/>
            <a:ext cx="1626946" cy="232219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3 withdrew consent before MR1</a:t>
            </a:r>
          </a:p>
        </p:txBody>
      </p: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03695328-D269-401B-9F20-D615F31F881E}"/>
              </a:ext>
            </a:extLst>
          </p:cNvPr>
          <p:cNvCxnSpPr>
            <a:cxnSpLocks/>
          </p:cNvCxnSpPr>
          <p:nvPr/>
        </p:nvCxnSpPr>
        <p:spPr>
          <a:xfrm flipH="1" flipV="1">
            <a:off x="4935936" y="2887349"/>
            <a:ext cx="92659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TextBox 78">
            <a:extLst>
              <a:ext uri="{FF2B5EF4-FFF2-40B4-BE49-F238E27FC236}">
                <a16:creationId xmlns:a16="http://schemas.microsoft.com/office/drawing/2014/main" id="{C88C0D89-84D8-46E6-A541-598C18FB8B82}"/>
              </a:ext>
            </a:extLst>
          </p:cNvPr>
          <p:cNvSpPr txBox="1"/>
          <p:nvPr/>
        </p:nvSpPr>
        <p:spPr>
          <a:xfrm>
            <a:off x="3681790" y="2468517"/>
            <a:ext cx="1254146" cy="1554844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22 didn’t receive MR1 within trial at time of data extract:</a:t>
            </a:r>
          </a:p>
          <a:p>
            <a:pPr algn="ctr">
              <a:spcAft>
                <a:spcPts val="0"/>
              </a:spcAft>
            </a:pPr>
            <a:endParaRPr lang="en-GB" sz="800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3 withdrew consent </a:t>
            </a:r>
          </a:p>
          <a:p>
            <a:pPr marL="87313" indent="-87313"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4 withdrawn due to investigator discretion – exposure to measles before MR1 </a:t>
            </a: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3 lost to follow-up</a:t>
            </a: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2 withdrawn due to protocol deviation</a:t>
            </a:r>
          </a:p>
        </p:txBody>
      </p:sp>
      <p:sp>
        <p:nvSpPr>
          <p:cNvPr id="120" name="TextBox 78">
            <a:extLst>
              <a:ext uri="{FF2B5EF4-FFF2-40B4-BE49-F238E27FC236}">
                <a16:creationId xmlns:a16="http://schemas.microsoft.com/office/drawing/2014/main" id="{26165742-61A1-4E85-A83B-CDD837E466E0}"/>
              </a:ext>
            </a:extLst>
          </p:cNvPr>
          <p:cNvSpPr txBox="1"/>
          <p:nvPr/>
        </p:nvSpPr>
        <p:spPr>
          <a:xfrm>
            <a:off x="108374" y="3309241"/>
            <a:ext cx="1680751" cy="6653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1 didn’t receive MR2 within trial at time of data extract:</a:t>
            </a:r>
          </a:p>
          <a:p>
            <a:pPr algn="ctr">
              <a:spcAft>
                <a:spcPts val="0"/>
              </a:spcAft>
            </a:pPr>
            <a:endParaRPr lang="en-GB" sz="800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0 withdrew consent </a:t>
            </a:r>
          </a:p>
          <a:p>
            <a:pPr marL="87313" indent="-87313"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 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ost to follow-up</a:t>
            </a:r>
            <a:endParaRPr lang="en-GB" sz="800" dirty="0">
              <a:solidFill>
                <a:srgbClr val="000000"/>
              </a:solidFill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F3B51DFA-24F6-4B1E-AD59-33208B348DC2}"/>
              </a:ext>
            </a:extLst>
          </p:cNvPr>
          <p:cNvCxnSpPr>
            <a:cxnSpLocks/>
          </p:cNvCxnSpPr>
          <p:nvPr/>
        </p:nvCxnSpPr>
        <p:spPr>
          <a:xfrm flipH="1" flipV="1">
            <a:off x="1789125" y="3786398"/>
            <a:ext cx="938563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384E40AB-C4A4-4FF3-BDA1-8418B985A3D7}"/>
              </a:ext>
            </a:extLst>
          </p:cNvPr>
          <p:cNvCxnSpPr>
            <a:cxnSpLocks/>
          </p:cNvCxnSpPr>
          <p:nvPr/>
        </p:nvCxnSpPr>
        <p:spPr>
          <a:xfrm flipH="1">
            <a:off x="5862529" y="3794084"/>
            <a:ext cx="92659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4" name="TextBox 78">
            <a:extLst>
              <a:ext uri="{FF2B5EF4-FFF2-40B4-BE49-F238E27FC236}">
                <a16:creationId xmlns:a16="http://schemas.microsoft.com/office/drawing/2014/main" id="{89F43E1A-97B1-4F8D-BDCF-B1E7CAD1C8D6}"/>
              </a:ext>
            </a:extLst>
          </p:cNvPr>
          <p:cNvSpPr txBox="1"/>
          <p:nvPr/>
        </p:nvSpPr>
        <p:spPr>
          <a:xfrm>
            <a:off x="6789121" y="3664731"/>
            <a:ext cx="1123623" cy="103335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</a:t>
            </a: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didn’t receive MR2 within trial at time of data extract:</a:t>
            </a:r>
          </a:p>
          <a:p>
            <a:pPr algn="ctr">
              <a:spcAft>
                <a:spcPts val="0"/>
              </a:spcAft>
            </a:pPr>
            <a:endParaRPr lang="en-GB" sz="800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87313" indent="-87313"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4 not yet had vaccination visit</a:t>
            </a: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2 withdrew consent </a:t>
            </a:r>
          </a:p>
          <a:p>
            <a:pPr algn="ctr"/>
            <a:endParaRPr lang="en-GB" sz="800" dirty="0">
              <a:solidFill>
                <a:srgbClr val="000000"/>
              </a:solidFill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endParaRPr lang="en-GB" sz="800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7F58DBB5-D58B-4C59-B2CD-39C53B4B8D80}"/>
              </a:ext>
            </a:extLst>
          </p:cNvPr>
          <p:cNvCxnSpPr>
            <a:cxnSpLocks/>
          </p:cNvCxnSpPr>
          <p:nvPr/>
        </p:nvCxnSpPr>
        <p:spPr>
          <a:xfrm flipH="1">
            <a:off x="8877992" y="3773404"/>
            <a:ext cx="1095741" cy="11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TextBox 78">
            <a:extLst>
              <a:ext uri="{FF2B5EF4-FFF2-40B4-BE49-F238E27FC236}">
                <a16:creationId xmlns:a16="http://schemas.microsoft.com/office/drawing/2014/main" id="{999032BE-FD04-42C8-86C0-079394E6AD12}"/>
              </a:ext>
            </a:extLst>
          </p:cNvPr>
          <p:cNvSpPr txBox="1"/>
          <p:nvPr/>
        </p:nvSpPr>
        <p:spPr>
          <a:xfrm>
            <a:off x="9973732" y="3612539"/>
            <a:ext cx="1739689" cy="782875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3 didn’t receive MR2 within trial at time of data extract:</a:t>
            </a:r>
          </a:p>
          <a:p>
            <a:pPr algn="ctr">
              <a:spcAft>
                <a:spcPts val="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</a:p>
          <a:p>
            <a:pPr marL="87313" indent="-87313"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6 not yet had vaccination visit</a:t>
            </a:r>
          </a:p>
          <a:p>
            <a:pPr marL="87313" indent="-87313"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6 withdrew consent </a:t>
            </a:r>
          </a:p>
          <a:p>
            <a:pPr marL="87313" indent="-87313">
              <a:buFont typeface="Arial" panose="020B0604020202020204" pitchFamily="34" charset="0"/>
              <a:buChar char="•"/>
              <a:tabLst>
                <a:tab pos="87313" algn="l"/>
              </a:tabLst>
            </a:pPr>
            <a:r>
              <a:rPr lang="en-GB" sz="8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=1 child death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FE854E2E-83B9-D386-593B-0E94B16AA86E}"/>
              </a:ext>
            </a:extLst>
          </p:cNvPr>
          <p:cNvCxnSpPr>
            <a:cxnSpLocks/>
          </p:cNvCxnSpPr>
          <p:nvPr/>
        </p:nvCxnSpPr>
        <p:spPr>
          <a:xfrm>
            <a:off x="2727687" y="2828854"/>
            <a:ext cx="0" cy="39426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22464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9</TotalTime>
  <Words>372</Words>
  <Application>Microsoft Office PowerPoint</Application>
  <PresentationFormat>Widescreen</PresentationFormat>
  <Paragraphs>5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lie Marchevsky</dc:creator>
  <cp:lastModifiedBy>Natalie Marchevsky</cp:lastModifiedBy>
  <cp:revision>48</cp:revision>
  <dcterms:created xsi:type="dcterms:W3CDTF">2024-08-20T09:46:01Z</dcterms:created>
  <dcterms:modified xsi:type="dcterms:W3CDTF">2025-08-21T11:53:54Z</dcterms:modified>
</cp:coreProperties>
</file>